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sz="24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99"/>
    <p:restoredTop sz="94674"/>
  </p:normalViewPr>
  <p:slideViewPr>
    <p:cSldViewPr snapToGrid="0" snapToObjects="1">
      <p:cViewPr>
        <p:scale>
          <a:sx n="86" d="100"/>
          <a:sy n="86" d="100"/>
        </p:scale>
        <p:origin x="-3492" y="-3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8BDF1-749E-6845-88DF-B0CA42FEB8DF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89AC6F-E8B0-1A46-9B97-CE3251CD8E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857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sz="160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841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878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06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791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98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431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51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586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152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531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113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C0CEF-513C-514B-9AF2-41B42CE0F986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618AB-81AB-CF41-9A6A-E7E605A430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8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932B202-E980-4A41-A48F-3E2C8D00CC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7550" y="1783525"/>
            <a:ext cx="3967158" cy="2981141"/>
          </a:xfrm>
          <a:prstGeom prst="rect">
            <a:avLst/>
          </a:prstGeom>
          <a:ln>
            <a:solidFill>
              <a:schemeClr val="bg2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123EDC89-1524-354B-8FF4-E78CAF621D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7550" y="4963845"/>
            <a:ext cx="4023430" cy="3605381"/>
          </a:xfrm>
          <a:prstGeom prst="rect">
            <a:avLst/>
          </a:prstGeom>
          <a:ln>
            <a:solidFill>
              <a:schemeClr val="bg2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FB86ABF-535B-B742-9EAE-34A5C0BB8485}"/>
              </a:ext>
            </a:extLst>
          </p:cNvPr>
          <p:cNvSpPr txBox="1"/>
          <p:nvPr/>
        </p:nvSpPr>
        <p:spPr>
          <a:xfrm>
            <a:off x="393649" y="707257"/>
            <a:ext cx="31290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00" dirty="0"/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2C324643-C0EC-9F40-8786-3697FBC86A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80314" y="1783524"/>
            <a:ext cx="998595" cy="143797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21748DA-DC92-F446-ADA6-99D47BF722A4}"/>
              </a:ext>
            </a:extLst>
          </p:cNvPr>
          <p:cNvSpPr txBox="1"/>
          <p:nvPr/>
        </p:nvSpPr>
        <p:spPr>
          <a:xfrm>
            <a:off x="349921" y="1575583"/>
            <a:ext cx="32573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00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FE50010-1F99-FA47-B87F-87E1C772BA63}"/>
              </a:ext>
            </a:extLst>
          </p:cNvPr>
          <p:cNvSpPr txBox="1"/>
          <p:nvPr/>
        </p:nvSpPr>
        <p:spPr>
          <a:xfrm>
            <a:off x="425179" y="5210221"/>
            <a:ext cx="29848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00" dirty="0"/>
              <a:t>c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xmlns="" id="{590F26CD-68CA-9548-A216-ED2750F704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876024"/>
              </p:ext>
            </p:extLst>
          </p:nvPr>
        </p:nvGraphicFramePr>
        <p:xfrm>
          <a:off x="844062" y="801860"/>
          <a:ext cx="5462145" cy="76731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94035">
                  <a:extLst>
                    <a:ext uri="{9D8B030D-6E8A-4147-A177-3AD203B41FA5}">
                      <a16:colId xmlns:a16="http://schemas.microsoft.com/office/drawing/2014/main" xmlns="" val="618632976"/>
                    </a:ext>
                  </a:extLst>
                </a:gridCol>
                <a:gridCol w="1013840">
                  <a:extLst>
                    <a:ext uri="{9D8B030D-6E8A-4147-A177-3AD203B41FA5}">
                      <a16:colId xmlns:a16="http://schemas.microsoft.com/office/drawing/2014/main" xmlns="" val="3492590565"/>
                    </a:ext>
                  </a:extLst>
                </a:gridCol>
                <a:gridCol w="1295824">
                  <a:extLst>
                    <a:ext uri="{9D8B030D-6E8A-4147-A177-3AD203B41FA5}">
                      <a16:colId xmlns:a16="http://schemas.microsoft.com/office/drawing/2014/main" xmlns="" val="3367423113"/>
                    </a:ext>
                  </a:extLst>
                </a:gridCol>
                <a:gridCol w="1358446">
                  <a:extLst>
                    <a:ext uri="{9D8B030D-6E8A-4147-A177-3AD203B41FA5}">
                      <a16:colId xmlns:a16="http://schemas.microsoft.com/office/drawing/2014/main" xmlns="" val="2971433864"/>
                    </a:ext>
                  </a:extLst>
                </a:gridCol>
              </a:tblGrid>
              <a:tr h="279632">
                <a:tc>
                  <a:txBody>
                    <a:bodyPr/>
                    <a:lstStyle/>
                    <a:p>
                      <a:r>
                        <a:rPr lang="en-US" sz="1000" dirty="0"/>
                        <a:t>Functions Annotation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baseline="0" dirty="0"/>
                        <a:t>P</a:t>
                      </a:r>
                      <a:r>
                        <a:rPr lang="en-US" sz="1000" dirty="0"/>
                        <a:t>- 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redicted Activ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ctivation Z-scor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86634337"/>
                  </a:ext>
                </a:extLst>
              </a:tr>
              <a:tr h="225944">
                <a:tc>
                  <a:txBody>
                    <a:bodyPr/>
                    <a:lstStyle/>
                    <a:p>
                      <a:r>
                        <a:rPr lang="en-US" sz="1000" dirty="0"/>
                        <a:t>Immune response of cel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4.79E-1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creased</a:t>
                      </a:r>
                    </a:p>
                  </a:txBody>
                  <a:tcP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2,834</a:t>
                      </a:r>
                    </a:p>
                  </a:txBody>
                  <a:tcPr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98965901"/>
                  </a:ext>
                </a:extLst>
              </a:tr>
              <a:tr h="225944">
                <a:tc>
                  <a:txBody>
                    <a:bodyPr/>
                    <a:lstStyle/>
                    <a:p>
                      <a:r>
                        <a:rPr lang="en-US" sz="1000" dirty="0"/>
                        <a:t>Invasion of cel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2.01E-1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creased</a:t>
                      </a:r>
                    </a:p>
                  </a:txBody>
                  <a:tcP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2.864</a:t>
                      </a:r>
                    </a:p>
                  </a:txBody>
                  <a:tcPr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23427048"/>
                  </a:ext>
                </a:extLst>
              </a:tr>
            </a:tbl>
          </a:graphicData>
        </a:graphic>
      </p:graphicFrame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xmlns="" id="{851E4A66-3D27-5042-9EE1-A3AE880664ED}"/>
              </a:ext>
            </a:extLst>
          </p:cNvPr>
          <p:cNvCxnSpPr/>
          <p:nvPr/>
        </p:nvCxnSpPr>
        <p:spPr>
          <a:xfrm>
            <a:off x="858059" y="1315894"/>
            <a:ext cx="544814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13DE5B01-E73D-724F-B61A-F37230196127}"/>
              </a:ext>
            </a:extLst>
          </p:cNvPr>
          <p:cNvCxnSpPr/>
          <p:nvPr/>
        </p:nvCxnSpPr>
        <p:spPr>
          <a:xfrm>
            <a:off x="858059" y="1569172"/>
            <a:ext cx="544814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9B7D4DCB-9207-804A-A9A1-C34340910BC1}"/>
              </a:ext>
            </a:extLst>
          </p:cNvPr>
          <p:cNvSpPr txBox="1"/>
          <p:nvPr/>
        </p:nvSpPr>
        <p:spPr>
          <a:xfrm>
            <a:off x="351625" y="211015"/>
            <a:ext cx="11382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/>
              <a:t>Figure </a:t>
            </a:r>
            <a:r>
              <a:rPr lang="en-US" sz="2000" smtClean="0"/>
              <a:t>S2</a:t>
            </a:r>
            <a:endParaRPr lang="en-US" sz="20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AC90A126-F105-E546-82EE-9509B091D4A9}"/>
              </a:ext>
            </a:extLst>
          </p:cNvPr>
          <p:cNvSpPr/>
          <p:nvPr/>
        </p:nvSpPr>
        <p:spPr>
          <a:xfrm>
            <a:off x="518747" y="8655864"/>
            <a:ext cx="6107136" cy="11439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(</a:t>
            </a:r>
            <a:r>
              <a:rPr lang="en-US" sz="1200" dirty="0" err="1">
                <a:latin typeface="Arial" panose="020B0604020202020204" pitchFamily="34" charset="0"/>
                <a:ea typeface="MS Mincho" panose="02020609040205080304" pitchFamily="49" charset="-128"/>
              </a:rPr>
              <a:t>a,b,c</a:t>
            </a:r>
            <a:r>
              <a:rPr lang="en-US" sz="1200" dirty="0">
                <a:latin typeface="Arial" panose="020B0604020202020204" pitchFamily="34" charset="0"/>
                <a:ea typeface="MS Mincho" panose="02020609040205080304" pitchFamily="49" charset="-128"/>
              </a:rPr>
              <a:t>) Shows functional predicted networks from RNAseq data of circANKRD12 silenced  MDA-MB-231 cells induces inflammatory immune responses and cancer cell invasion with activation Z score and p values.</a:t>
            </a:r>
            <a:endParaRPr lang="en-US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031584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57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sni K.A. Azis</dc:creator>
  <cp:lastModifiedBy>JABELLA</cp:lastModifiedBy>
  <cp:revision>20</cp:revision>
  <cp:lastPrinted>2018-07-04T09:23:57Z</cp:lastPrinted>
  <dcterms:created xsi:type="dcterms:W3CDTF">2018-07-04T08:59:04Z</dcterms:created>
  <dcterms:modified xsi:type="dcterms:W3CDTF">2019-05-18T01:33:16Z</dcterms:modified>
</cp:coreProperties>
</file>